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media/image3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792913" cy="99822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F69D7D-D34A-4B3E-9B29-1092D35B73B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038AB3-5AC8-49A3-A2AD-63AADA5A091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46B6A9-D277-46BA-A2DF-96F7CBB9106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782F6B-9118-4AA1-9FEF-C8A4E5FDCB7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6C98EE-3751-4987-B098-75F65687AD9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EA34FB-6AB9-4320-8123-519C28543D8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502066-EA66-4EA0-A5AE-3ED2864F693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76393B-F488-40BA-B8A9-F3CE407D73D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B11DB1-660A-4082-8033-95D3EFA27A7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52BBA6-0CA0-4BF3-82B7-E033F41ABF1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33D4AA-F276-478C-A6A1-6368F37D56F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85DD28-C4E1-4A81-BFC4-2C20AAC666F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020160"/>
            <a:ext cx="217152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BB05BC0-E433-4DED-997C-7DF23799DD17}" type="slidenum">
              <a:rPr b="0" lang="de-DE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slideLayout" Target="../slideLayouts/slideLayout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745200" y="1206360"/>
            <a:ext cx="1009800" cy="322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500" spc="-1" strike="noStrike">
                <a:solidFill>
                  <a:srgbClr val="000000"/>
                </a:solidFill>
                <a:latin typeface="Arial"/>
              </a:rPr>
              <a:t>Figure S1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" name="" descr=""/>
          <p:cNvPicPr/>
          <p:nvPr/>
        </p:nvPicPr>
        <p:blipFill>
          <a:blip r:embed="rId1">
            <a:lum contrast="24000"/>
          </a:blip>
          <a:stretch/>
        </p:blipFill>
        <p:spPr>
          <a:xfrm>
            <a:off x="1557360" y="4826160"/>
            <a:ext cx="1871640" cy="599760"/>
          </a:xfrm>
          <a:prstGeom prst="rect">
            <a:avLst/>
          </a:prstGeom>
          <a:ln w="0">
            <a:noFill/>
          </a:ln>
        </p:spPr>
      </p:pic>
      <p:pic>
        <p:nvPicPr>
          <p:cNvPr id="43" name="" descr=""/>
          <p:cNvPicPr/>
          <p:nvPr/>
        </p:nvPicPr>
        <p:blipFill>
          <a:blip r:embed="rId2">
            <a:lum bright="6000"/>
          </a:blip>
          <a:stretch/>
        </p:blipFill>
        <p:spPr>
          <a:xfrm>
            <a:off x="1628640" y="2278080"/>
            <a:ext cx="1079640" cy="568440"/>
          </a:xfrm>
          <a:prstGeom prst="rect">
            <a:avLst/>
          </a:prstGeom>
          <a:ln w="0">
            <a:noFill/>
          </a:ln>
        </p:spPr>
      </p:pic>
      <p:sp>
        <p:nvSpPr>
          <p:cNvPr id="44" name=""/>
          <p:cNvSpPr/>
          <p:nvPr/>
        </p:nvSpPr>
        <p:spPr>
          <a:xfrm>
            <a:off x="1666440" y="1905120"/>
            <a:ext cx="1067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c     ab    neg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1642320" y="4570560"/>
            <a:ext cx="1741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c      ab     c     ab   neg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 flipH="1">
            <a:off x="2855880" y="2457360"/>
            <a:ext cx="50328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3313800" y="2313000"/>
            <a:ext cx="973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</a:rPr>
              <a:t>Pim1 (152 bp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 flipH="1">
            <a:off x="2852640" y="2616120"/>
            <a:ext cx="50328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3312000" y="2500200"/>
            <a:ext cx="953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</a:rPr>
              <a:t>primer dimer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 flipH="1">
            <a:off x="3486240" y="5014800"/>
            <a:ext cx="50328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3943080" y="4870440"/>
            <a:ext cx="1276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</a:rPr>
              <a:t>GADD45B (249 bp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 flipH="1">
            <a:off x="3483000" y="5240160"/>
            <a:ext cx="50328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3942000" y="5124600"/>
            <a:ext cx="953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</a:rPr>
              <a:t>primer dimer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1675080" y="4376880"/>
            <a:ext cx="1329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549       Caco-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1652400" y="1743120"/>
            <a:ext cx="648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2C1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1666440" y="3147840"/>
            <a:ext cx="1067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c     ab    neg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 flipH="1">
            <a:off x="2855880" y="3672000"/>
            <a:ext cx="50328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3311640" y="3527280"/>
            <a:ext cx="1206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</a:rPr>
              <a:t>Gadd45b (230 bp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 flipH="1">
            <a:off x="2852640" y="3859200"/>
            <a:ext cx="50328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3312000" y="3743280"/>
            <a:ext cx="953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</a:rPr>
              <a:t>primer dimer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1652400" y="2986200"/>
            <a:ext cx="648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2C1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2" name="" descr=""/>
          <p:cNvPicPr/>
          <p:nvPr/>
        </p:nvPicPr>
        <p:blipFill>
          <a:blip r:embed="rId3">
            <a:lum bright="12000"/>
          </a:blip>
          <a:stretch/>
        </p:blipFill>
        <p:spPr>
          <a:xfrm>
            <a:off x="1633680" y="3443400"/>
            <a:ext cx="1128600" cy="5349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12-12T11:28:27Z</dcterms:created>
  <dc:creator>kmaaser</dc:creator>
  <dc:description/>
  <dc:language>en-US</dc:language>
  <cp:lastModifiedBy>k.Narasimhan</cp:lastModifiedBy>
  <dcterms:modified xsi:type="dcterms:W3CDTF">2008-10-23T02:20:14Z</dcterms:modified>
  <cp:revision>55</cp:revision>
  <dc:subject/>
  <dc:title>Folie 1</dc:title>
</cp:coreProperties>
</file>